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6200438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25055" y="1122363"/>
            <a:ext cx="12150329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3602038"/>
            <a:ext cx="12150329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69765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46925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39" y="365125"/>
            <a:ext cx="3493219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0" y="365125"/>
            <a:ext cx="10277153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52374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76368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2" y="1709739"/>
            <a:ext cx="1397287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2" y="4589464"/>
            <a:ext cx="1397287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59161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1825625"/>
            <a:ext cx="6885186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1825625"/>
            <a:ext cx="6885186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0941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365126"/>
            <a:ext cx="13972878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1" y="1681163"/>
            <a:ext cx="68535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1" y="2505075"/>
            <a:ext cx="6853544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2" y="1681163"/>
            <a:ext cx="688729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2" y="2505075"/>
            <a:ext cx="6887296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69352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8134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54966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457200"/>
            <a:ext cx="522506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987426"/>
            <a:ext cx="8201472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2057400"/>
            <a:ext cx="5225062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30595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457200"/>
            <a:ext cx="522506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987426"/>
            <a:ext cx="8201472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2057400"/>
            <a:ext cx="5225062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6944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365126"/>
            <a:ext cx="1397287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1825625"/>
            <a:ext cx="1397287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6356351"/>
            <a:ext cx="36450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EA9E6-FBBC-4E93-AA4B-C02DFF4AF3A3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6356351"/>
            <a:ext cx="546764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6356351"/>
            <a:ext cx="36450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1D420B-A729-45B6-8D7B-15C6D0A51E2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0574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5106248"/>
            <a:ext cx="1620043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</a:rPr>
              <a:t>Figure S1: </a:t>
            </a:r>
            <a:endParaRPr lang="en-US" b="1" dirty="0" smtClean="0">
              <a:latin typeface="Times New Roman" panose="02020603050405020304" pitchFamily="18" charset="0"/>
            </a:endParaRPr>
          </a:p>
          <a:p>
            <a:pPr algn="just"/>
            <a:r>
              <a:rPr lang="en-US" dirty="0" smtClean="0">
                <a:latin typeface="Times New Roman" panose="02020603050405020304" pitchFamily="18" charset="0"/>
              </a:rPr>
              <a:t>(</a:t>
            </a:r>
            <a:r>
              <a:rPr lang="en-US" dirty="0">
                <a:latin typeface="Times New Roman" panose="02020603050405020304" pitchFamily="18" charset="0"/>
              </a:rPr>
              <a:t>A) Principal </a:t>
            </a:r>
            <a:r>
              <a:rPr lang="en-US" dirty="0">
                <a:latin typeface="Times New Roman" panose="02020603050405020304" pitchFamily="18" charset="0"/>
              </a:rPr>
              <a:t>coordinates analysis (</a:t>
            </a:r>
            <a:r>
              <a:rPr lang="en-US" dirty="0" err="1">
                <a:latin typeface="Times New Roman" panose="02020603050405020304" pitchFamily="18" charset="0"/>
              </a:rPr>
              <a:t>PCoA</a:t>
            </a:r>
            <a:r>
              <a:rPr lang="en-US" dirty="0">
                <a:latin typeface="Times New Roman" panose="02020603050405020304" pitchFamily="18" charset="0"/>
              </a:rPr>
              <a:t>) based on </a:t>
            </a:r>
            <a:r>
              <a:rPr lang="en-US" dirty="0" smtClean="0">
                <a:latin typeface="Times New Roman" panose="02020603050405020304" pitchFamily="18" charset="0"/>
              </a:rPr>
              <a:t>weighted </a:t>
            </a:r>
            <a:r>
              <a:rPr lang="en-US" dirty="0" smtClean="0">
                <a:latin typeface="Times New Roman" panose="02020603050405020304" pitchFamily="18" charset="0"/>
              </a:rPr>
              <a:t>and </a:t>
            </a:r>
            <a:r>
              <a:rPr lang="en-US" dirty="0">
                <a:latin typeface="Times New Roman" panose="02020603050405020304" pitchFamily="18" charset="0"/>
              </a:rPr>
              <a:t>unweighted </a:t>
            </a:r>
            <a:r>
              <a:rPr lang="en-US" dirty="0" err="1" smtClean="0">
                <a:latin typeface="Times New Roman" panose="02020603050405020304" pitchFamily="18" charset="0"/>
              </a:rPr>
              <a:t>UniFrac</a:t>
            </a:r>
            <a:r>
              <a:rPr lang="en-US" smtClean="0">
                <a:latin typeface="Times New Roman" panose="02020603050405020304" pitchFamily="18" charset="0"/>
              </a:rPr>
              <a:t> distances between </a:t>
            </a:r>
            <a:r>
              <a:rPr lang="en-US" dirty="0">
                <a:latin typeface="Times New Roman" panose="02020603050405020304" pitchFamily="18" charset="0"/>
              </a:rPr>
              <a:t>microbial communities of the wastewater samples used for the three sets of experiments (baseline experiments, clean anode), as indicated by the different colors. PC, principle coordinate</a:t>
            </a:r>
            <a:r>
              <a:rPr lang="en-US" dirty="0" smtClean="0">
                <a:latin typeface="Times New Roman" panose="02020603050405020304" pitchFamily="18" charset="0"/>
              </a:rPr>
              <a:t>.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</a:rPr>
              <a:t>(B) Representative growth curves of two MFCs, displaying a 3-stage growth curve (gray, efficient MFC) or a 4-stage growth curve (black, non-efficient MFC). </a:t>
            </a:r>
            <a:endParaRPr lang="he-IL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8820263"/>
              </p:ext>
            </p:extLst>
          </p:nvPr>
        </p:nvGraphicFramePr>
        <p:xfrm>
          <a:off x="114615" y="155022"/>
          <a:ext cx="11117783" cy="41194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5" r:id="rId3" imgW="9232560" imgH="3421440" progId="Prism5.Document">
                  <p:embed/>
                </p:oleObj>
              </mc:Choice>
              <mc:Fallback>
                <p:oleObj name="Prism 5" r:id="rId3" imgW="9232560" imgH="342144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4615" y="155022"/>
                        <a:ext cx="11117783" cy="41194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14615" y="155022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</a:rPr>
              <a:t>A</a:t>
            </a:r>
            <a:endParaRPr lang="en-US" sz="1400" dirty="0"/>
          </a:p>
        </p:txBody>
      </p:sp>
      <p:sp>
        <p:nvSpPr>
          <p:cNvPr id="7" name="Rectangle 6"/>
          <p:cNvSpPr/>
          <p:nvPr/>
        </p:nvSpPr>
        <p:spPr>
          <a:xfrm>
            <a:off x="11332284" y="155022"/>
            <a:ext cx="3298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</a:rPr>
              <a:t>B</a:t>
            </a:r>
            <a:endParaRPr lang="en-US" sz="1400" dirty="0"/>
          </a:p>
        </p:txBody>
      </p:sp>
      <p:grpSp>
        <p:nvGrpSpPr>
          <p:cNvPr id="8" name="Group 7"/>
          <p:cNvGrpSpPr/>
          <p:nvPr/>
        </p:nvGrpSpPr>
        <p:grpSpPr>
          <a:xfrm>
            <a:off x="11274212" y="462799"/>
            <a:ext cx="4732880" cy="3875285"/>
            <a:chOff x="527538" y="1062375"/>
            <a:chExt cx="4732880" cy="3875285"/>
          </a:xfrm>
        </p:grpSpPr>
        <p:grpSp>
          <p:nvGrpSpPr>
            <p:cNvPr id="9" name="קבוצה 35">
              <a:extLst>
                <a:ext uri="{FF2B5EF4-FFF2-40B4-BE49-F238E27FC236}">
                  <a16:creationId xmlns:a16="http://schemas.microsoft.com/office/drawing/2014/main" id="{64495F62-D8AB-4DC6-89F9-6739352D701E}"/>
                </a:ext>
              </a:extLst>
            </p:cNvPr>
            <p:cNvGrpSpPr/>
            <p:nvPr/>
          </p:nvGrpSpPr>
          <p:grpSpPr>
            <a:xfrm>
              <a:off x="527538" y="1062375"/>
              <a:ext cx="4732880" cy="3875285"/>
              <a:chOff x="2655275" y="277285"/>
              <a:chExt cx="4732880" cy="3875285"/>
            </a:xfrm>
          </p:grpSpPr>
          <p:grpSp>
            <p:nvGrpSpPr>
              <p:cNvPr id="12" name="קבוצה 1">
                <a:extLst>
                  <a:ext uri="{FF2B5EF4-FFF2-40B4-BE49-F238E27FC236}">
                    <a16:creationId xmlns:a16="http://schemas.microsoft.com/office/drawing/2014/main" id="{9EB58BF0-A171-47F1-8EA1-2E57EE88C80F}"/>
                  </a:ext>
                </a:extLst>
              </p:cNvPr>
              <p:cNvGrpSpPr/>
              <p:nvPr/>
            </p:nvGrpSpPr>
            <p:grpSpPr>
              <a:xfrm>
                <a:off x="4933775" y="3890960"/>
                <a:ext cx="1304663" cy="261610"/>
                <a:chOff x="7631648" y="327287"/>
                <a:chExt cx="1304663" cy="261610"/>
              </a:xfrm>
            </p:grpSpPr>
            <p:sp>
              <p:nvSpPr>
                <p:cNvPr id="32" name="TextBox 24">
                  <a:extLst>
                    <a:ext uri="{FF2B5EF4-FFF2-40B4-BE49-F238E27FC236}">
                      <a16:creationId xmlns:a16="http://schemas.microsoft.com/office/drawing/2014/main" id="{C5CC0CA3-91E9-47A5-8D1B-296442288B6D}"/>
                    </a:ext>
                  </a:extLst>
                </p:cNvPr>
                <p:cNvSpPr txBox="1"/>
                <p:nvPr/>
              </p:nvSpPr>
              <p:spPr>
                <a:xfrm>
                  <a:off x="7631648" y="327287"/>
                  <a:ext cx="1304663" cy="26161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 rtl="0"/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-phase startup</a:t>
                  </a:r>
                  <a:endParaRPr lang="he-IL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Oval 25">
                  <a:extLst>
                    <a:ext uri="{FF2B5EF4-FFF2-40B4-BE49-F238E27FC236}">
                      <a16:creationId xmlns:a16="http://schemas.microsoft.com/office/drawing/2014/main" id="{888991FF-F889-4F72-9806-6BE7878C03EA}"/>
                    </a:ext>
                  </a:extLst>
                </p:cNvPr>
                <p:cNvSpPr/>
                <p:nvPr/>
              </p:nvSpPr>
              <p:spPr>
                <a:xfrm>
                  <a:off x="7639522" y="417303"/>
                  <a:ext cx="108000" cy="108000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1" anchor="ctr"/>
                <a:lstStyle/>
                <a:p>
                  <a:pPr algn="ctr"/>
                  <a:endParaRPr lang="he-IL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" name="קבוצה 2">
                <a:extLst>
                  <a:ext uri="{FF2B5EF4-FFF2-40B4-BE49-F238E27FC236}">
                    <a16:creationId xmlns:a16="http://schemas.microsoft.com/office/drawing/2014/main" id="{C6AAE880-C315-433A-825E-E6D6B3ED3C3A}"/>
                  </a:ext>
                </a:extLst>
              </p:cNvPr>
              <p:cNvGrpSpPr/>
              <p:nvPr/>
            </p:nvGrpSpPr>
            <p:grpSpPr>
              <a:xfrm>
                <a:off x="3711605" y="3890960"/>
                <a:ext cx="1304663" cy="261610"/>
                <a:chOff x="7631648" y="63249"/>
                <a:chExt cx="1304663" cy="261610"/>
              </a:xfrm>
            </p:grpSpPr>
            <p:sp>
              <p:nvSpPr>
                <p:cNvPr id="30" name="TextBox 24">
                  <a:extLst>
                    <a:ext uri="{FF2B5EF4-FFF2-40B4-BE49-F238E27FC236}">
                      <a16:creationId xmlns:a16="http://schemas.microsoft.com/office/drawing/2014/main" id="{827D5044-52BD-4DF3-9A89-86CE49D221EC}"/>
                    </a:ext>
                  </a:extLst>
                </p:cNvPr>
                <p:cNvSpPr txBox="1"/>
                <p:nvPr/>
              </p:nvSpPr>
              <p:spPr>
                <a:xfrm>
                  <a:off x="7631648" y="63249"/>
                  <a:ext cx="1304663" cy="26161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 rtl="0"/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-phase startup</a:t>
                  </a:r>
                  <a:endParaRPr lang="he-IL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Oval 26">
                  <a:extLst>
                    <a:ext uri="{FF2B5EF4-FFF2-40B4-BE49-F238E27FC236}">
                      <a16:creationId xmlns:a16="http://schemas.microsoft.com/office/drawing/2014/main" id="{09AE1828-E709-47C1-8865-AC65C0AE4817}"/>
                    </a:ext>
                  </a:extLst>
                </p:cNvPr>
                <p:cNvSpPr/>
                <p:nvPr/>
              </p:nvSpPr>
              <p:spPr>
                <a:xfrm>
                  <a:off x="7639522" y="153265"/>
                  <a:ext cx="108000" cy="108000"/>
                </a:xfrm>
                <a:prstGeom prst="ellipse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1" anchor="ctr"/>
                <a:lstStyle/>
                <a:p>
                  <a:pPr algn="ctr"/>
                  <a:endParaRPr lang="he-IL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" name="קבוצה 26">
                <a:extLst>
                  <a:ext uri="{FF2B5EF4-FFF2-40B4-BE49-F238E27FC236}">
                    <a16:creationId xmlns:a16="http://schemas.microsoft.com/office/drawing/2014/main" id="{4052B045-2637-4345-B5FD-DF1B91053BE1}"/>
                  </a:ext>
                </a:extLst>
              </p:cNvPr>
              <p:cNvGrpSpPr/>
              <p:nvPr/>
            </p:nvGrpSpPr>
            <p:grpSpPr>
              <a:xfrm>
                <a:off x="2655275" y="277285"/>
                <a:ext cx="4732880" cy="3601215"/>
                <a:chOff x="2655275" y="277285"/>
                <a:chExt cx="4732880" cy="3601215"/>
              </a:xfrm>
            </p:grpSpPr>
            <p:graphicFrame>
              <p:nvGraphicFramePr>
                <p:cNvPr id="15" name="Object 14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701191143"/>
                    </p:ext>
                  </p:extLst>
                </p:nvPr>
              </p:nvGraphicFramePr>
              <p:xfrm>
                <a:off x="2655275" y="764804"/>
                <a:ext cx="4541115" cy="311369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31" name="Prism 5" r:id="rId5" imgW="4873680" imgH="3342240" progId="Prism5.Document">
                        <p:embed/>
                      </p:oleObj>
                    </mc:Choice>
                    <mc:Fallback>
                      <p:oleObj name="Prism 5" r:id="rId5" imgW="4873680" imgH="3342240" progId="Prism5.Document">
                        <p:embed/>
                        <p:pic>
                          <p:nvPicPr>
                            <p:cNvPr id="13" name="Object 12"/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655275" y="764804"/>
                              <a:ext cx="4541115" cy="3113696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6" name="Group 36">
                  <a:extLst>
                    <a:ext uri="{FF2B5EF4-FFF2-40B4-BE49-F238E27FC236}">
                      <a16:creationId xmlns:a16="http://schemas.microsoft.com/office/drawing/2014/main" id="{DB9AC6F0-F74A-4F8A-9B9F-C983D2661448}"/>
                    </a:ext>
                  </a:extLst>
                </p:cNvPr>
                <p:cNvGrpSpPr/>
                <p:nvPr/>
              </p:nvGrpSpPr>
              <p:grpSpPr>
                <a:xfrm>
                  <a:off x="3303584" y="277285"/>
                  <a:ext cx="4084571" cy="2802342"/>
                  <a:chOff x="2394362" y="1549682"/>
                  <a:chExt cx="4084571" cy="2802342"/>
                </a:xfrm>
              </p:grpSpPr>
              <p:grpSp>
                <p:nvGrpSpPr>
                  <p:cNvPr id="17" name="Group 34">
                    <a:extLst>
                      <a:ext uri="{FF2B5EF4-FFF2-40B4-BE49-F238E27FC236}">
                        <a16:creationId xmlns:a16="http://schemas.microsoft.com/office/drawing/2014/main" id="{6411B0AC-9BF4-4EF2-B0FA-87D9E611DCD4}"/>
                      </a:ext>
                    </a:extLst>
                  </p:cNvPr>
                  <p:cNvGrpSpPr/>
                  <p:nvPr/>
                </p:nvGrpSpPr>
                <p:grpSpPr>
                  <a:xfrm>
                    <a:off x="2394362" y="1549682"/>
                    <a:ext cx="4084571" cy="2802342"/>
                    <a:chOff x="2394362" y="1549682"/>
                    <a:chExt cx="4084571" cy="2802342"/>
                  </a:xfrm>
                </p:grpSpPr>
                <p:sp>
                  <p:nvSpPr>
                    <p:cNvPr id="19" name="TextBox 21">
                      <a:extLst>
                        <a:ext uri="{FF2B5EF4-FFF2-40B4-BE49-F238E27FC236}">
                          <a16:creationId xmlns:a16="http://schemas.microsoft.com/office/drawing/2014/main" id="{13CCC671-66B6-441A-9618-B54F8A50AF5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03665" y="3956806"/>
                      <a:ext cx="1217197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1">
                      <a:spAutoFit/>
                    </a:bodyPr>
                    <a:lstStyle/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 II</a:t>
                      </a:r>
                      <a:endParaRPr lang="he-IL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" name="Rectangle 6">
                      <a:extLst>
                        <a:ext uri="{FF2B5EF4-FFF2-40B4-BE49-F238E27FC236}">
                          <a16:creationId xmlns:a16="http://schemas.microsoft.com/office/drawing/2014/main" id="{687B0D71-45E3-4C75-9FE5-6631571EE0B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394362" y="3921137"/>
                      <a:ext cx="688009" cy="43088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l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 I</a:t>
                      </a:r>
                    </a:p>
                    <a:p>
                      <a:pPr algn="l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g time</a:t>
                      </a:r>
                      <a:endParaRPr lang="he-IL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21" name="מחבר חץ ישר 31">
                      <a:extLst>
                        <a:ext uri="{FF2B5EF4-FFF2-40B4-BE49-F238E27FC236}">
                          <a16:creationId xmlns:a16="http://schemas.microsoft.com/office/drawing/2014/main" id="{DF3F8950-7E69-4010-A796-62023A9C280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247808" y="2914037"/>
                      <a:ext cx="216024" cy="504056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headEnd type="none" w="med" len="med"/>
                      <a:tailEnd type="triangle" w="med" len="med"/>
                    </a:ln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" name="TextBox 10">
                      <a:extLst>
                        <a:ext uri="{FF2B5EF4-FFF2-40B4-BE49-F238E27FC236}">
                          <a16:creationId xmlns:a16="http://schemas.microsoft.com/office/drawing/2014/main" id="{B272A675-0E18-4BEE-8E31-79003AF719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1744" y="2452372"/>
                      <a:ext cx="1224136" cy="43088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1">
                      <a:spAutoFit/>
                    </a:bodyPr>
                    <a:lstStyle/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onential </a:t>
                      </a:r>
                    </a:p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, III</a:t>
                      </a:r>
                      <a:endParaRPr lang="he-IL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3" name="TextBox 12">
                      <a:extLst>
                        <a:ext uri="{FF2B5EF4-FFF2-40B4-BE49-F238E27FC236}">
                          <a16:creationId xmlns:a16="http://schemas.microsoft.com/office/drawing/2014/main" id="{7BD3DE6B-467E-497D-B8DD-B0F18DA061F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92113" y="2952433"/>
                      <a:ext cx="1411935" cy="43088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1">
                      <a:spAutoFit/>
                    </a:bodyPr>
                    <a:lstStyle/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onential </a:t>
                      </a:r>
                    </a:p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, III</a:t>
                      </a:r>
                      <a:endParaRPr lang="he-IL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24" name="מחבר חץ ישר 36">
                      <a:extLst>
                        <a:ext uri="{FF2B5EF4-FFF2-40B4-BE49-F238E27FC236}">
                          <a16:creationId xmlns:a16="http://schemas.microsoft.com/office/drawing/2014/main" id="{BBBDFE95-5A7D-4DD8-B1A8-A9394D5B4CA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955867" y="2057050"/>
                      <a:ext cx="0" cy="671822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headEnd type="none" w="med" len="med"/>
                      <a:tailEnd type="triangle" w="med" len="med"/>
                    </a:ln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" name="TextBox 14">
                      <a:extLst>
                        <a:ext uri="{FF2B5EF4-FFF2-40B4-BE49-F238E27FC236}">
                          <a16:creationId xmlns:a16="http://schemas.microsoft.com/office/drawing/2014/main" id="{FF73B883-D750-45F8-9C97-DEE61E7C67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54931" y="1549682"/>
                      <a:ext cx="1808440" cy="43088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rtlCol="1">
                      <a:spAutoFit/>
                    </a:bodyPr>
                    <a:lstStyle/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up time</a:t>
                      </a:r>
                    </a:p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ure phase, IV</a:t>
                      </a:r>
                      <a:endParaRPr lang="he-IL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26" name="מחבר חץ ישר 39">
                      <a:extLst>
                        <a:ext uri="{FF2B5EF4-FFF2-40B4-BE49-F238E27FC236}">
                          <a16:creationId xmlns:a16="http://schemas.microsoft.com/office/drawing/2014/main" id="{756B3DD2-C232-410C-906B-96EDD5ECD19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499142" y="2068925"/>
                      <a:ext cx="0" cy="648072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headEnd type="none" w="med" len="med"/>
                      <a:tailEnd type="triangle" w="med" len="med"/>
                    </a:ln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7" name="TextBox 16">
                      <a:extLst>
                        <a:ext uri="{FF2B5EF4-FFF2-40B4-BE49-F238E27FC236}">
                          <a16:creationId xmlns:a16="http://schemas.microsoft.com/office/drawing/2014/main" id="{C3030A8C-1349-4C88-B392-73D51A339C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26198" y="1549682"/>
                      <a:ext cx="1952735" cy="43088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rtlCol="1">
                      <a:spAutoFit/>
                    </a:bodyPr>
                    <a:lstStyle/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up time</a:t>
                      </a:r>
                    </a:p>
                    <a:p>
                      <a:pPr algn="ctr" rtl="0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ure phase, IV</a:t>
                      </a:r>
                      <a:endParaRPr lang="he-IL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28" name="Straight Connector 18">
                      <a:extLst>
                        <a:ext uri="{FF2B5EF4-FFF2-40B4-BE49-F238E27FC236}">
                          <a16:creationId xmlns:a16="http://schemas.microsoft.com/office/drawing/2014/main" id="{A9878E8D-A8AD-47BA-BE22-FBD4C551415B}"/>
                        </a:ext>
                      </a:extLst>
                    </p:cNvPr>
                    <p:cNvCxnSpPr/>
                    <p:nvPr/>
                  </p:nvCxnSpPr>
                  <p:spPr>
                    <a:xfrm rot="16200000">
                      <a:off x="2724085" y="4071354"/>
                      <a:ext cx="0" cy="540000"/>
                    </a:xfrm>
                    <a:prstGeom prst="line">
                      <a:avLst/>
                    </a:prstGeom>
                    <a:ln w="19050">
                      <a:solidFill>
                        <a:schemeClr val="bg2">
                          <a:lumMod val="10000"/>
                        </a:schemeClr>
                      </a:solidFill>
                      <a:prstDash val="sysDash"/>
                      <a:headEnd type="none" w="med" len="med"/>
                      <a:tailEnd type="none" w="med" len="med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" name="Straight Connector 20">
                      <a:extLst>
                        <a:ext uri="{FF2B5EF4-FFF2-40B4-BE49-F238E27FC236}">
                          <a16:creationId xmlns:a16="http://schemas.microsoft.com/office/drawing/2014/main" id="{84F99D75-249F-421D-A073-436D2590A9F3}"/>
                        </a:ext>
                      </a:extLst>
                    </p:cNvPr>
                    <p:cNvCxnSpPr/>
                    <p:nvPr/>
                  </p:nvCxnSpPr>
                  <p:spPr>
                    <a:xfrm rot="16200000">
                      <a:off x="3753538" y="3512580"/>
                      <a:ext cx="0" cy="136800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  <a:prstDash val="sysDash"/>
                      <a:headEnd type="none" w="med" len="med"/>
                      <a:tailEnd type="none" w="med" len="med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8" name="מחבר חץ ישר 31">
                    <a:extLst>
                      <a:ext uri="{FF2B5EF4-FFF2-40B4-BE49-F238E27FC236}">
                        <a16:creationId xmlns:a16="http://schemas.microsoft.com/office/drawing/2014/main" id="{73F7FC39-5125-43CE-9B0A-60618AC11642}"/>
                      </a:ext>
                    </a:extLst>
                  </p:cNvPr>
                  <p:cNvCxnSpPr/>
                  <p:nvPr/>
                </p:nvCxnSpPr>
                <p:spPr>
                  <a:xfrm>
                    <a:off x="4312193" y="3486106"/>
                    <a:ext cx="141563" cy="36529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none" w="med" len="med"/>
                    <a:tailEnd type="triangle" w="med" len="med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10" name="TextBox 24">
              <a:extLst>
                <a:ext uri="{FF2B5EF4-FFF2-40B4-BE49-F238E27FC236}">
                  <a16:creationId xmlns:a16="http://schemas.microsoft.com/office/drawing/2014/main" id="{827D5044-52BD-4DF3-9A89-86CE49D221EC}"/>
                </a:ext>
              </a:extLst>
            </p:cNvPr>
            <p:cNvSpPr txBox="1"/>
            <p:nvPr/>
          </p:nvSpPr>
          <p:spPr>
            <a:xfrm>
              <a:off x="2236199" y="4335457"/>
              <a:ext cx="130466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day)</a:t>
              </a:r>
              <a:endParaRPr lang="he-I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24">
              <a:extLst>
                <a:ext uri="{FF2B5EF4-FFF2-40B4-BE49-F238E27FC236}">
                  <a16:creationId xmlns:a16="http://schemas.microsoft.com/office/drawing/2014/main" id="{827D5044-52BD-4DF3-9A89-86CE49D221EC}"/>
                </a:ext>
              </a:extLst>
            </p:cNvPr>
            <p:cNvSpPr txBox="1"/>
            <p:nvPr/>
          </p:nvSpPr>
          <p:spPr>
            <a:xfrm rot="16200000">
              <a:off x="89412" y="2743522"/>
              <a:ext cx="130466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oltage (mV)</a:t>
              </a:r>
              <a:endParaRPr lang="he-I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4" name="Rectangle 33"/>
          <p:cNvSpPr/>
          <p:nvPr/>
        </p:nvSpPr>
        <p:spPr>
          <a:xfrm>
            <a:off x="6570130" y="462799"/>
            <a:ext cx="21852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</a:rPr>
              <a:t>Unweighted </a:t>
            </a:r>
            <a:r>
              <a:rPr lang="en-US" dirty="0" err="1">
                <a:latin typeface="Times New Roman" panose="02020603050405020304" pitchFamily="18" charset="0"/>
              </a:rPr>
              <a:t>UniFrac</a:t>
            </a:r>
            <a:r>
              <a:rPr lang="en-US" dirty="0">
                <a:latin typeface="Times New Roman" panose="02020603050405020304" pitchFamily="18" charset="0"/>
              </a:rPr>
              <a:t> </a:t>
            </a:r>
            <a:endParaRPr lang="he-IL" dirty="0"/>
          </a:p>
        </p:txBody>
      </p:sp>
      <p:sp>
        <p:nvSpPr>
          <p:cNvPr id="35" name="Rectangle 34"/>
          <p:cNvSpPr/>
          <p:nvPr/>
        </p:nvSpPr>
        <p:spPr>
          <a:xfrm>
            <a:off x="1894730" y="462799"/>
            <a:ext cx="1935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</a:rPr>
              <a:t>Weighted </a:t>
            </a:r>
            <a:r>
              <a:rPr lang="en-US" dirty="0" err="1">
                <a:latin typeface="Times New Roman" panose="02020603050405020304" pitchFamily="18" charset="0"/>
              </a:rPr>
              <a:t>UniFrac</a:t>
            </a:r>
            <a:r>
              <a:rPr lang="en-US" dirty="0">
                <a:latin typeface="Times New Roman" panose="02020603050405020304" pitchFamily="18" charset="0"/>
              </a:rPr>
              <a:t> 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2496398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28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5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2</cp:revision>
  <dcterms:created xsi:type="dcterms:W3CDTF">2020-02-16T08:58:31Z</dcterms:created>
  <dcterms:modified xsi:type="dcterms:W3CDTF">2020-02-16T09:04:13Z</dcterms:modified>
</cp:coreProperties>
</file>